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E304D-3F10-41E8-9B6C-501EF7CC66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B34A6-6DBE-402F-ADAC-1A3CA0A168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9CDC9-9D93-4538-A8FC-4E44758ABF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85B3A-C468-4D27-ABFE-8115EA43F3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9BDF1-BEE3-45B2-8FC7-A20F111EFA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35815-0F8E-4CAF-BBD8-C110D8EF5B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E735B-36EC-4882-8F48-DAA4458447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1A050-0D11-4CF1-9575-84D16B37E4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FFD59-943E-42BE-AC4C-5B05704AF4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6F5FB-3ACA-420F-800B-14B0433BE8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DC906-9B52-4487-96F8-A86095B897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30394-B677-4A88-8101-A44445360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FAE914-C754-4532-ACD8-34E734893D5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54684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0" y="2669400"/>
            <a:ext cx="62182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ummary of subgroup analysis with Bonferroni’s Multiple Comparison test of short-chain acyl-CoA dehydrogenase deficiency (SCADD) under each experimental condition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 Ns = not significant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The p-values confirm the more significant effect of hyperthermia compared to hypoglycemia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900000" y="1219320"/>
          <a:ext cx="4064040" cy="1066680"/>
        </p:xfrm>
        <a:graphic>
          <a:graphicData uri="http://schemas.openxmlformats.org/drawingml/2006/table">
            <a:tbl>
              <a:tblPr/>
              <a:tblGrid>
                <a:gridCol w="2032200"/>
                <a:gridCol w="2031840"/>
              </a:tblGrid>
              <a:tr h="355320"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 Glucose vs 37 No Gluco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5680"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 Glucose vs 39 Gluco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&lt;0.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5680"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 Glucose vs 39 No Gluco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6600" rIns="6660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&lt;0.0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6600" marR="66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49:37Z</dcterms:modified>
  <cp:revision>33</cp:revision>
  <dc:subject/>
  <dc:title>Slide 1</dc:title>
</cp:coreProperties>
</file>